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>
        <p:scale>
          <a:sx n="59" d="100"/>
          <a:sy n="59" d="100"/>
        </p:scale>
        <p:origin x="-1188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109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20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144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828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947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52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277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181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828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21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365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99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creenshot&#10;&#10;Description automatically generated">
            <a:extLst>
              <a:ext uri="{FF2B5EF4-FFF2-40B4-BE49-F238E27FC236}">
                <a16:creationId xmlns="" xmlns:a16="http://schemas.microsoft.com/office/drawing/2014/main" id="{9F37C004-71FC-4E08-89FC-5DB4E18780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6387" y="1357312"/>
            <a:ext cx="9039225" cy="41433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842866C-2403-48B4-A461-CFF8EB384E0C}"/>
              </a:ext>
            </a:extLst>
          </p:cNvPr>
          <p:cNvSpPr txBox="1"/>
          <p:nvPr/>
        </p:nvSpPr>
        <p:spPr>
          <a:xfrm flipH="1">
            <a:off x="1294488" y="5568286"/>
            <a:ext cx="97670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: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oxalse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domain position in AtGLYI2, AtGLYI3 and at AtGLYI6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s indicate the amino acid position in the protein.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LYI2 has single domain and size of 27 KD. While AtGLYI3 and AtGLYI6 have two domains and size of 37 and 42 KD respectively (Jain et al 2016). 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8455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7</TotalTime>
  <Words>57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turaj Batth</dc:creator>
  <cp:lastModifiedBy>Vijayakumar AG</cp:lastModifiedBy>
  <cp:revision>103</cp:revision>
  <dcterms:created xsi:type="dcterms:W3CDTF">2019-10-06T16:26:31Z</dcterms:created>
  <dcterms:modified xsi:type="dcterms:W3CDTF">2020-05-18T18:54:09Z</dcterms:modified>
</cp:coreProperties>
</file>